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5" d="100"/>
          <a:sy n="75" d="100"/>
        </p:scale>
        <p:origin x="94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281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9916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727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7053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106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7306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116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15503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859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2389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1707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EEF20F-21E1-4986-A72A-B1CC1F5E1FBA}" type="datetimeFigureOut">
              <a:rPr lang="en-US" smtClean="0"/>
              <a:t>4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26B41-0CC2-4826-AF43-9B343C166A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6312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54658" y="2444264"/>
            <a:ext cx="4220308" cy="5184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769" b="1" dirty="0">
                <a:solidFill>
                  <a:srgbClr val="FF0000"/>
                </a:solidFill>
              </a:rPr>
              <a:t>Supplementary </a:t>
            </a:r>
            <a:r>
              <a:rPr lang="en-US" sz="2769" b="1" dirty="0" smtClean="0">
                <a:solidFill>
                  <a:srgbClr val="FF0000"/>
                </a:solidFill>
              </a:rPr>
              <a:t>figures</a:t>
            </a:r>
            <a:endParaRPr lang="en-US" sz="2769" b="1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332743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04078" y="1044526"/>
            <a:ext cx="4440626" cy="3138854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997716" y="4804746"/>
            <a:ext cx="4253349" cy="44416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762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r>
              <a:rPr lang="de-DE" sz="762" b="1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b-proteins network of  common exosomal proteins among SAL, Enz, AA or Dar treatments.</a:t>
            </a:r>
          </a:p>
          <a:p>
            <a:pPr algn="just"/>
            <a:r>
              <a:rPr lang="de-DE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 was drawn by cytoscape (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nnon P, et al. </a:t>
            </a:r>
            <a:r>
              <a:rPr lang="en-US" sz="762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research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2003</a:t>
            </a:r>
            <a:r>
              <a:rPr lang="de-DE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n=4. </a:t>
            </a:r>
          </a:p>
        </p:txBody>
      </p:sp>
      <p:sp>
        <p:nvSpPr>
          <p:cNvPr id="4" name="Textfeld 1">
            <a:extLst>
              <a:ext uri="{FF2B5EF4-FFF2-40B4-BE49-F238E27FC236}">
                <a16:creationId xmlns:a16="http://schemas.microsoft.com/office/drawing/2014/main" id="{3075E6CF-6280-8470-C752-A57895A9AA24}"/>
              </a:ext>
            </a:extLst>
          </p:cNvPr>
          <p:cNvSpPr txBox="1"/>
          <p:nvPr/>
        </p:nvSpPr>
        <p:spPr>
          <a:xfrm>
            <a:off x="7371621" y="6496801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</a:t>
            </a:r>
            <a:endParaRPr lang="de-DE" sz="1246" dirty="0"/>
          </a:p>
        </p:txBody>
      </p:sp>
    </p:spTree>
    <p:extLst>
      <p:ext uri="{BB962C8B-B14F-4D97-AF65-F5344CB8AC3E}">
        <p14:creationId xmlns:p14="http://schemas.microsoft.com/office/powerpoint/2010/main" val="3494782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901440" y="4093440"/>
            <a:ext cx="4568483" cy="83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97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The secretion of ANG, a SASP key factor, is differently regulated by AR-agonist and -antagonists. </a:t>
            </a:r>
          </a:p>
          <a:p>
            <a:pPr algn="just"/>
            <a:r>
              <a:rPr lang="en-GB" sz="97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G protein level is enhanced upon SAL treatment. ANG (Angiogenin). Detection of PSA was used as a control. Below represents another Western blot of secreted factors with longer exposure time for PSA detection.</a:t>
            </a:r>
            <a:endParaRPr lang="en-US" sz="97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feld 1">
            <a:extLst>
              <a:ext uri="{FF2B5EF4-FFF2-40B4-BE49-F238E27FC236}">
                <a16:creationId xmlns:a16="http://schemas.microsoft.com/office/drawing/2014/main" id="{BAB71D83-A9E0-BD4C-6CBC-658A76746BC3}"/>
              </a:ext>
            </a:extLst>
          </p:cNvPr>
          <p:cNvSpPr txBox="1"/>
          <p:nvPr/>
        </p:nvSpPr>
        <p:spPr>
          <a:xfrm>
            <a:off x="7635144" y="6602309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de-DE" sz="1246" dirty="0"/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1548" y="332227"/>
            <a:ext cx="3794385" cy="170093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49850" y="2310069"/>
            <a:ext cx="2663245" cy="11438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26931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0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3128976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64723" y="246059"/>
            <a:ext cx="4060277" cy="2930023"/>
          </a:xfrm>
          <a:prstGeom prst="rect">
            <a:avLst/>
          </a:prstGeom>
        </p:spPr>
      </p:pic>
      <p:sp>
        <p:nvSpPr>
          <p:cNvPr id="5" name="Textfeld 1">
            <a:extLst>
              <a:ext uri="{FF2B5EF4-FFF2-40B4-BE49-F238E27FC236}">
                <a16:creationId xmlns:a16="http://schemas.microsoft.com/office/drawing/2014/main" id="{BAB71D83-A9E0-BD4C-6CBC-658A76746BC3}"/>
              </a:ext>
            </a:extLst>
          </p:cNvPr>
          <p:cNvSpPr txBox="1"/>
          <p:nvPr/>
        </p:nvSpPr>
        <p:spPr>
          <a:xfrm>
            <a:off x="7635144" y="6602309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de-DE" sz="1246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8579" y="3468146"/>
            <a:ext cx="4277261" cy="28446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9575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0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feld 2">
            <a:extLst>
              <a:ext uri="{FF2B5EF4-FFF2-40B4-BE49-F238E27FC236}">
                <a16:creationId xmlns:a16="http://schemas.microsoft.com/office/drawing/2014/main" id="{A5B5D375-F2C0-7A74-1A8A-97B11C6019D6}"/>
              </a:ext>
            </a:extLst>
          </p:cNvPr>
          <p:cNvSpPr txBox="1"/>
          <p:nvPr/>
        </p:nvSpPr>
        <p:spPr>
          <a:xfrm>
            <a:off x="7588419" y="6456709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de-DE" sz="1246" dirty="0"/>
          </a:p>
        </p:txBody>
      </p:sp>
      <p:sp>
        <p:nvSpPr>
          <p:cNvPr id="5" name="TextBox 4"/>
          <p:cNvSpPr txBox="1"/>
          <p:nvPr/>
        </p:nvSpPr>
        <p:spPr>
          <a:xfrm>
            <a:off x="4145249" y="4776780"/>
            <a:ext cx="4114723" cy="10305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Identification of 103 commonly up-regulated proteins in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somes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creted by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treated by SAL or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est enriched pathways according to 103 common proteins. Dots indicate number of significant proteins in the given enriched pathway. Color indicates –log10 (lowest p-value). 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 visualizes which factors are involved in the enriched pathway and how the proteins are connected in different pathways. Pathways in the network are shown according to the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D number. 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Set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shows a matrix of enriched pathways and the number of proteins at the corresponding intersections of enriched pathways. 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5963" y="356620"/>
            <a:ext cx="4224009" cy="41493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57554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0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876826" y="3269193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feld 1">
            <a:extLst>
              <a:ext uri="{FF2B5EF4-FFF2-40B4-BE49-F238E27FC236}">
                <a16:creationId xmlns:a16="http://schemas.microsoft.com/office/drawing/2014/main" id="{59303848-47CD-4AC6-91E2-CD01F327295D}"/>
              </a:ext>
            </a:extLst>
          </p:cNvPr>
          <p:cNvSpPr txBox="1"/>
          <p:nvPr/>
        </p:nvSpPr>
        <p:spPr>
          <a:xfrm>
            <a:off x="7490209" y="6450485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de-DE" sz="1246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64292" y="268999"/>
            <a:ext cx="3125917" cy="25181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91586" y="3707785"/>
            <a:ext cx="3820353" cy="2518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650368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6" y="189136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4145249" y="4790687"/>
            <a:ext cx="3934296" cy="10305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. 11 down-regulated common proteins in exosomes secreted by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ells treated by SAL and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algn="just"/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est enriched pathways according to 11 common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xosomal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s. Dot indicates number of significant proteins in the given enriched pathway. Color indicates –log10 (lowest p-value). 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 visualizes which factors are involved in the enriched pathway and  how the proteins are connected in different pathways. Pathways in the network are shown according to the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D number. 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Set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shows a matrix of enriched pathways and the number of proteins at the corresponding intersections of enriched pathways.</a:t>
            </a:r>
            <a:endParaRPr lang="en-US" sz="762" dirty="0"/>
          </a:p>
        </p:txBody>
      </p:sp>
      <p:sp>
        <p:nvSpPr>
          <p:cNvPr id="5" name="Textfeld 1">
            <a:extLst>
              <a:ext uri="{FF2B5EF4-FFF2-40B4-BE49-F238E27FC236}">
                <a16:creationId xmlns:a16="http://schemas.microsoft.com/office/drawing/2014/main" id="{59303848-47CD-4AC6-91E2-CD01F327295D}"/>
              </a:ext>
            </a:extLst>
          </p:cNvPr>
          <p:cNvSpPr txBox="1"/>
          <p:nvPr/>
        </p:nvSpPr>
        <p:spPr>
          <a:xfrm>
            <a:off x="7490209" y="6450485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</a:t>
            </a:r>
            <a:endParaRPr lang="de-DE" sz="1246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95283" y="420850"/>
            <a:ext cx="4574640" cy="3515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8543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0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feld 11">
            <a:extLst>
              <a:ext uri="{FF2B5EF4-FFF2-40B4-BE49-F238E27FC236}">
                <a16:creationId xmlns:a16="http://schemas.microsoft.com/office/drawing/2014/main" id="{52D65CAA-6459-7EA0-691E-FB9E9B523328}"/>
              </a:ext>
            </a:extLst>
          </p:cNvPr>
          <p:cNvSpPr txBox="1"/>
          <p:nvPr/>
        </p:nvSpPr>
        <p:spPr>
          <a:xfrm>
            <a:off x="7490209" y="6479950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de-DE" sz="1246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0318" y="550024"/>
            <a:ext cx="2476156" cy="275236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50318" y="3766963"/>
            <a:ext cx="2866630" cy="2918312"/>
          </a:xfrm>
          <a:prstGeom prst="rect">
            <a:avLst/>
          </a:prstGeom>
        </p:spPr>
      </p:pic>
      <p:sp>
        <p:nvSpPr>
          <p:cNvPr id="7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5624880" y="117604"/>
            <a:ext cx="787643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8" b="1" dirty="0"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8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5624880" y="3438418"/>
            <a:ext cx="787643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8" b="1" dirty="0">
                <a:latin typeface="Arial" panose="020B0604020202020204" pitchFamily="34" charset="0"/>
                <a:cs typeface="Arial" panose="020B0604020202020204" pitchFamily="34" charset="0"/>
              </a:rPr>
              <a:t>Enz</a:t>
            </a:r>
          </a:p>
        </p:txBody>
      </p:sp>
    </p:spTree>
    <p:extLst>
      <p:ext uri="{BB962C8B-B14F-4D97-AF65-F5344CB8AC3E}">
        <p14:creationId xmlns:p14="http://schemas.microsoft.com/office/powerpoint/2010/main" val="2483441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0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Textfeld 2">
            <a:extLst>
              <a:ext uri="{FF2B5EF4-FFF2-40B4-BE49-F238E27FC236}">
                <a16:creationId xmlns:a16="http://schemas.microsoft.com/office/drawing/2014/main" id="{C15307E1-79DA-AC12-BF69-D3F2164A5E83}"/>
              </a:ext>
            </a:extLst>
          </p:cNvPr>
          <p:cNvSpPr txBox="1"/>
          <p:nvPr/>
        </p:nvSpPr>
        <p:spPr>
          <a:xfrm>
            <a:off x="7632130" y="6471587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de-DE" sz="1246" dirty="0"/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39065" y="350092"/>
            <a:ext cx="3923745" cy="246657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9065" y="3773409"/>
            <a:ext cx="3967089" cy="2511424"/>
          </a:xfrm>
          <a:prstGeom prst="rect">
            <a:avLst/>
          </a:prstGeom>
        </p:spPr>
      </p:pic>
      <p:sp>
        <p:nvSpPr>
          <p:cNvPr id="8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5624880" y="117604"/>
            <a:ext cx="787643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8" b="1" dirty="0"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9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5624880" y="3605423"/>
            <a:ext cx="787643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8" b="1" dirty="0">
                <a:latin typeface="Arial" panose="020B0604020202020204" pitchFamily="34" charset="0"/>
                <a:cs typeface="Arial" panose="020B0604020202020204" pitchFamily="34" charset="0"/>
              </a:rPr>
              <a:t>Enz</a:t>
            </a:r>
          </a:p>
        </p:txBody>
      </p:sp>
    </p:spTree>
    <p:extLst>
      <p:ext uri="{BB962C8B-B14F-4D97-AF65-F5344CB8AC3E}">
        <p14:creationId xmlns:p14="http://schemas.microsoft.com/office/powerpoint/2010/main" val="71104449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22077" y="211015"/>
            <a:ext cx="3395463" cy="2968826"/>
          </a:xfrm>
          <a:prstGeom prst="rect">
            <a:avLst/>
          </a:prstGeom>
        </p:spPr>
      </p:pic>
      <p:sp>
        <p:nvSpPr>
          <p:cNvPr id="8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4404069" y="864818"/>
            <a:ext cx="787643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8" b="1" dirty="0">
                <a:latin typeface="Arial" panose="020B0604020202020204" pitchFamily="34" charset="0"/>
                <a:cs typeface="Arial" panose="020B0604020202020204" pitchFamily="34" charset="0"/>
              </a:rPr>
              <a:t>SAL</a:t>
            </a:r>
          </a:p>
        </p:txBody>
      </p:sp>
      <p:sp>
        <p:nvSpPr>
          <p:cNvPr id="10" name="Textfeld 1">
            <a:extLst>
              <a:ext uri="{FF2B5EF4-FFF2-40B4-BE49-F238E27FC236}">
                <a16:creationId xmlns:a16="http://schemas.microsoft.com/office/drawing/2014/main" id="{25471718-D195-2388-AC9F-88328A479183}"/>
              </a:ext>
            </a:extLst>
          </p:cNvPr>
          <p:cNvSpPr txBox="1"/>
          <p:nvPr/>
        </p:nvSpPr>
        <p:spPr>
          <a:xfrm>
            <a:off x="7371621" y="6496801"/>
            <a:ext cx="979714" cy="2840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246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</a:t>
            </a:r>
            <a:endParaRPr lang="de-DE" sz="1246" dirty="0"/>
          </a:p>
        </p:txBody>
      </p:sp>
      <p:pic>
        <p:nvPicPr>
          <p:cNvPr id="3" name="Picture 4">
            <a:extLst>
              <a:ext uri="{FF2B5EF4-FFF2-40B4-BE49-F238E27FC236}">
                <a16:creationId xmlns:a16="http://schemas.microsoft.com/office/drawing/2014/main" id="{D7485346-EA24-FB0E-595D-2E6AAE6F517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74241" y="3429001"/>
            <a:ext cx="3291135" cy="2923138"/>
          </a:xfrm>
          <a:prstGeom prst="rect">
            <a:avLst/>
          </a:prstGeom>
        </p:spPr>
      </p:pic>
      <p:sp>
        <p:nvSpPr>
          <p:cNvPr id="4" name="Textfeld 37">
            <a:extLst>
              <a:ext uri="{FF2B5EF4-FFF2-40B4-BE49-F238E27FC236}">
                <a16:creationId xmlns:a16="http://schemas.microsoft.com/office/drawing/2014/main" id="{54D18BA5-8D87-1E6F-7659-1B7CB37C119C}"/>
              </a:ext>
            </a:extLst>
          </p:cNvPr>
          <p:cNvSpPr txBox="1"/>
          <p:nvPr/>
        </p:nvSpPr>
        <p:spPr>
          <a:xfrm>
            <a:off x="4435859" y="4462009"/>
            <a:ext cx="579695" cy="262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8" b="1" dirty="0">
                <a:latin typeface="Arial" panose="020B0604020202020204" pitchFamily="34" charset="0"/>
                <a:cs typeface="Arial" panose="020B0604020202020204" pitchFamily="34" charset="0"/>
              </a:rPr>
              <a:t>Enz</a:t>
            </a:r>
          </a:p>
        </p:txBody>
      </p:sp>
      <p:sp>
        <p:nvSpPr>
          <p:cNvPr id="2" name="Textfeld 37">
            <a:extLst>
              <a:ext uri="{FF2B5EF4-FFF2-40B4-BE49-F238E27FC236}">
                <a16:creationId xmlns:a16="http://schemas.microsoft.com/office/drawing/2014/main" id="{107FCCB6-A6F2-4FF7-BA4A-8F5B7F1F27D9}"/>
              </a:ext>
            </a:extLst>
          </p:cNvPr>
          <p:cNvSpPr txBox="1"/>
          <p:nvPr/>
        </p:nvSpPr>
        <p:spPr>
          <a:xfrm>
            <a:off x="3926207" y="211016"/>
            <a:ext cx="438085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62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2">
            <a:extLst>
              <a:ext uri="{FF2B5EF4-FFF2-40B4-BE49-F238E27FC236}">
                <a16:creationId xmlns:a16="http://schemas.microsoft.com/office/drawing/2014/main" id="{CF183E8E-B994-0B38-2BD2-D7579ED315DC}"/>
              </a:ext>
            </a:extLst>
          </p:cNvPr>
          <p:cNvSpPr txBox="1"/>
          <p:nvPr/>
        </p:nvSpPr>
        <p:spPr>
          <a:xfrm>
            <a:off x="6835419" y="1902398"/>
            <a:ext cx="1634505" cy="2320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20 up-regulated proteins by SAL and down-regulated by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z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rom </a:t>
            </a:r>
            <a:r>
              <a:rPr lang="en-US" sz="762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ecreted exosomes. </a:t>
            </a:r>
          </a:p>
          <a:p>
            <a:pPr algn="just"/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Highest enriched pathways according to 20 factors. Dot indicates number of significant proteins in the given enriched pathway. Color indicates –log10 (lowest p-value). 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Network visualizes which factors are involved in the enriched pathway and connection between protein in different pathways. Pathways in the network are shown according to the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actome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D number. </a:t>
            </a:r>
            <a:r>
              <a:rPr lang="en-US" sz="7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: </a:t>
            </a:r>
            <a:r>
              <a:rPr lang="en-US" sz="762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UpSet</a:t>
            </a:r>
            <a:r>
              <a:rPr lang="en-US" sz="762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lot shows a matrix of enriched pathways and the number of factors at the corresponding intersections of enriched pathways.</a:t>
            </a:r>
            <a:endParaRPr lang="en-US" sz="762" dirty="0"/>
          </a:p>
        </p:txBody>
      </p:sp>
    </p:spTree>
    <p:extLst>
      <p:ext uri="{BB962C8B-B14F-4D97-AF65-F5344CB8AC3E}">
        <p14:creationId xmlns:p14="http://schemas.microsoft.com/office/powerpoint/2010/main" val="29123913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55</Words>
  <Application>Microsoft Office PowerPoint</Application>
  <PresentationFormat>Widescreen</PresentationFormat>
  <Paragraphs>35</Paragraphs>
  <Slides>10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lia</dc:creator>
  <cp:lastModifiedBy>golia</cp:lastModifiedBy>
  <cp:revision>1</cp:revision>
  <dcterms:created xsi:type="dcterms:W3CDTF">2024-04-03T13:18:03Z</dcterms:created>
  <dcterms:modified xsi:type="dcterms:W3CDTF">2024-04-03T13:18:32Z</dcterms:modified>
</cp:coreProperties>
</file>